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6858000" cy="9906000" type="A4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60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57150" y="210185"/>
            <a:ext cx="2133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298200" y="210185"/>
            <a:ext cx="2133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539250" y="210185"/>
            <a:ext cx="236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5400" y="3198674"/>
            <a:ext cx="6807200" cy="116955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. Y chr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mosome-related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GSVA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res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ross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fferent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thological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oups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4-NQO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.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t plots depict GSVA scores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oding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Y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genes in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ongu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normal),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remalignan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OPMD) and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dividual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se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GSE75421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GSE164619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B), and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E229289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mouse_GSE229289_dotplo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666615" y="633730"/>
            <a:ext cx="2191385" cy="2191385"/>
          </a:xfrm>
          <a:prstGeom prst="rect">
            <a:avLst/>
          </a:prstGeom>
        </p:spPr>
      </p:pic>
      <p:pic>
        <p:nvPicPr>
          <p:cNvPr id="6" name="图片 5" descr="mouse_GSE75421_dotplot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115" y="632460"/>
            <a:ext cx="2190750" cy="2190750"/>
          </a:xfrm>
          <a:prstGeom prst="rect">
            <a:avLst/>
          </a:prstGeom>
        </p:spPr>
      </p:pic>
      <p:pic>
        <p:nvPicPr>
          <p:cNvPr id="10" name="图片 9" descr="mouse_GSE164619_dotplot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2365" y="635000"/>
            <a:ext cx="2190115" cy="219011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GQ2OGFkOTMxOTRjMjAwNGJjNzU4YzIzNGY2NWUwNzUifQ==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1</Words>
  <Application>WPS 演示</Application>
  <PresentationFormat>A4-Papier (210 x 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宋体</vt:lpstr>
      <vt:lpstr>Wingdings</vt:lpstr>
      <vt:lpstr>微软雅黑</vt:lpstr>
      <vt:lpstr>Arial Unicode MS</vt:lpstr>
      <vt:lpstr>Offic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ß, Jochen</dc:creator>
  <cp:lastModifiedBy>韩蕊</cp:lastModifiedBy>
  <cp:revision>37</cp:revision>
  <dcterms:created xsi:type="dcterms:W3CDTF">2024-09-10T14:28:00Z</dcterms:created>
  <dcterms:modified xsi:type="dcterms:W3CDTF">2025-07-21T02:02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6E60A1633A442EAA0CE53EB4377AEE4_13</vt:lpwstr>
  </property>
  <property fmtid="{D5CDD505-2E9C-101B-9397-08002B2CF9AE}" pid="3" name="KSOProductBuildVer">
    <vt:lpwstr>2052-12.1.0.21915</vt:lpwstr>
  </property>
</Properties>
</file>